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US 2'!$B$2</c:f>
              <c:strCache>
                <c:ptCount val="1"/>
                <c:pt idx="0">
                  <c:v>North Americ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US 2'!$A$3:$A$6</c:f>
              <c:strCache>
                <c:ptCount val="4"/>
                <c:pt idx="0">
                  <c:v>Time constrains</c:v>
                </c:pt>
                <c:pt idx="1">
                  <c:v>Limited information available/provided</c:v>
                </c:pt>
                <c:pt idx="2">
                  <c:v>Organizational (e.g. not clear on roles and responsibilities between manufacturer and treating physician)</c:v>
                </c:pt>
                <c:pt idx="3">
                  <c:v>Financial</c:v>
                </c:pt>
              </c:strCache>
            </c:strRef>
          </c:cat>
          <c:val>
            <c:numRef>
              <c:f>'US 2'!$B$3:$B$6</c:f>
              <c:numCache>
                <c:formatCode>0.00%</c:formatCode>
                <c:ptCount val="4"/>
                <c:pt idx="0">
                  <c:v>0.82599999999999996</c:v>
                </c:pt>
                <c:pt idx="1">
                  <c:v>0.34799999999999998</c:v>
                </c:pt>
                <c:pt idx="2">
                  <c:v>0.47799999999999998</c:v>
                </c:pt>
                <c:pt idx="3">
                  <c:v>0.30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02-41F2-83AB-8828ED02CE10}"/>
            </c:ext>
          </c:extLst>
        </c:ser>
        <c:ser>
          <c:idx val="1"/>
          <c:order val="1"/>
          <c:tx>
            <c:strRef>
              <c:f>'US 2'!$C$2</c:f>
              <c:strCache>
                <c:ptCount val="1"/>
                <c:pt idx="0">
                  <c:v>Europe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US 2'!$A$3:$A$6</c:f>
              <c:strCache>
                <c:ptCount val="4"/>
                <c:pt idx="0">
                  <c:v>Time constrains</c:v>
                </c:pt>
                <c:pt idx="1">
                  <c:v>Limited information available/provided</c:v>
                </c:pt>
                <c:pt idx="2">
                  <c:v>Organizational (e.g. not clear on roles and responsibilities between manufacturer and treating physician)</c:v>
                </c:pt>
                <c:pt idx="3">
                  <c:v>Financial</c:v>
                </c:pt>
              </c:strCache>
            </c:strRef>
          </c:cat>
          <c:val>
            <c:numRef>
              <c:f>'US 2'!$C$3:$C$6</c:f>
              <c:numCache>
                <c:formatCode>0.00%</c:formatCode>
                <c:ptCount val="4"/>
                <c:pt idx="0">
                  <c:v>0.77100000000000002</c:v>
                </c:pt>
                <c:pt idx="1">
                  <c:v>0.41699999999999998</c:v>
                </c:pt>
                <c:pt idx="2">
                  <c:v>0.41699999999999998</c:v>
                </c:pt>
                <c:pt idx="3">
                  <c:v>0.271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02-41F2-83AB-8828ED02CE1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41325952"/>
        <c:axId val="741319392"/>
      </c:barChart>
      <c:catAx>
        <c:axId val="741325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741319392"/>
        <c:crosses val="autoZero"/>
        <c:auto val="1"/>
        <c:lblAlgn val="ctr"/>
        <c:lblOffset val="100"/>
        <c:noMultiLvlLbl val="0"/>
      </c:catAx>
      <c:valAx>
        <c:axId val="741319392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741325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0EEBA-388E-44E3-B1F0-66750EC2FB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B6FF07-2FC7-4A9B-9A48-DBD048976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9DAD7-CD0C-4C71-AD23-7D2F5AAFB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87D70-B5A3-4D3E-AAFA-B0DA8B91A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E2E8DB-B0B0-4E39-9EC0-004C76FAA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5442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BE366-A43D-4D8C-81A9-85871E0522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E85748-32D3-45E6-85AE-460B2D348F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36D355-28E6-4B62-BF00-F31EE1987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5AB4CB-7990-4834-8995-BB2811415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24DC6-0810-465F-9EC4-B9B951DC3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303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9E09B9-98B0-4C5B-8CBB-615415D71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A00DA7-6BE0-4EA2-8107-7116733390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79ECC-47F1-4447-B37C-1A6C2B15A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5C1339-819A-4F5F-9CEC-0AA70F02B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5BB0F-14F5-4A2F-A704-E4C70FCB3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129504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60FE9-566C-4D95-9304-401478008E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49D3B-AFAE-4FCE-86E6-515C5419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0AB1A-BB09-4DC7-9DDA-04302E7CA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CF127-C4DB-47AB-BABC-21651435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D5EEE-8411-4306-9019-EA284A8F4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64830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8BC7D-AB0D-4AC7-8EAB-3F0570B71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7DAD68-F6CD-40CB-82D4-7A4B321CA0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74B1B-DABA-419C-8E1D-F3D7E08F6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06877-630B-4658-ADE7-DB4FDB981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F129F-E00E-46CC-8478-8D53C7973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4768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A50A8-F3A6-4D3E-B313-DEF6A3E33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8C18B2-6DE4-48E7-8B96-BA8C85D0D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AD6B4-A94F-4CA4-8654-87F4C420E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FE9D5-EB32-4A51-97E3-82742131C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E3288-14D7-4252-8841-95697ACD3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72961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263EE-0D6C-4DC3-A033-63FC2D204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646ADC-CF01-44D7-A32A-3072C858CB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E8946B-EA93-4292-A38C-70E4F6CE4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3A1F2-89B8-40B9-9913-9E51C30A8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29439B-99D1-496F-BA97-A1A470C3C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852E6-4557-48B1-9344-A4176A518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6415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DF59-D8DB-42C7-9D6D-2324E6B5F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04F8E-912B-4644-AE6E-778AD0931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5C88E0-8A64-4157-9CCC-326B324E2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251E89-7B6C-4909-9013-52E8E27B9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9C570-FBD9-48AA-8844-03861D1947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6DF997-366A-4433-A0B3-3F4A70B0F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87223-6F68-4D82-99E5-9B93456BA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457904-6528-4962-8799-D344B9811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828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99DAA-8BB5-418A-8DD7-92FA9FAF0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9FB9E9-7F97-4014-AC6F-D5C409C0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C7FF6-5BB4-491F-ABDB-F79F5567D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86CF20-280E-4CF1-8E34-BDCCC0FA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22806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D37C83-1465-40FA-B60C-5A757A62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49D5DF-A388-42DF-AAC6-50E873BAF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24C439-7602-4E6C-93D8-AB9C9AC95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97893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AF85D-A3C7-40C0-AE79-2658B0501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D882E-166A-4741-8CAB-8B87F8601F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9B494D-1B4C-4B7C-81C2-ED69154AC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4E7A9F-92AF-4AA5-91D8-0D990E1CD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D82ED-ABBD-4ECA-B66B-92A2A0102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807BD-04BF-4C15-8702-78A0498A4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96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F0928-E7C7-4A64-978C-B44B292B6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7664F4-1B1E-47B7-A408-12C11513B2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87856E-FE89-4B8B-BC2D-B21918EB0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5E37D7-C1DF-4C77-B137-62818FE93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F0316-C882-4CC0-8935-34560B5E2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29696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B39FC-52B2-43AF-BFD4-2BC6A5867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64028-D7E6-40DE-9DB2-4C6B805434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A8C7E-5AD9-44E8-9FA9-0A142B11A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AE9D-6A51-4461-8D4B-182B72DE9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B7836-440A-479A-AA19-4F6F8F216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1617F-18C7-43B7-97CF-CD2D91726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2097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4A676-CB94-4DDF-B349-59436C5E4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21B5BC-5FB7-460D-B6C3-97897F7645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F0FAD-8A9C-4797-9712-ADC028C0A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DA043F-45C6-402B-B8E0-B8D1240E2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84154-F9ED-41F8-A5C9-D1ED3044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93222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6BDB66-BEA0-401C-BCA1-AF456A971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237161-9F41-4DC9-B35F-EBC2C1279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CB68E-250A-463A-AE06-4D42E146B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A8C4BF-BC95-40D3-95EA-0AB576787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6091E-421F-462F-84F1-33ECF01C0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782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D4DBA4-57F0-48C6-B984-5243EC48E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B9855C-3438-42A2-ACD0-A789D9002F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F5FBA-1C14-43E1-87F1-A59FDE5B1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513A2D-C5CC-4940-8124-63548B825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D19B4-3BA8-4906-ABDA-1DA48A2C5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9903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2C99A1-0C8D-45E2-A67B-404404159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DC2DB4-CDF7-4894-813E-DB3D39964C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0632E6-E3E6-4539-91E2-EAAB196CAF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A29F0C-E799-43DF-9A7D-6411C4936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614569-8912-471F-843C-C5EE4831F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0DE927-6A0D-49FD-BD3D-EB3E9DA08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299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27ED9-F642-40F3-AD36-98F576A52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BEF97-816E-4F35-AE5A-0F67FE9EA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FCD3CC-6B42-4142-9E59-62F0F1DDB4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38229C-1667-40B7-A33B-BFEB2DF858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42CCBE-EA6B-4013-852E-8305774CFA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8E4C8E-6899-4DA9-B458-C3E17D68D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FFAD70-ACF0-402F-81D3-0222DB742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42344B-2299-4F92-8413-CD0C9FEDB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036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941F8-EA90-4D19-91A0-20BE0E3D77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2070B8-35CC-4629-8647-AC082D6AF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271B91-AF79-4083-9FD4-D95F21B07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5D36E0-F210-458D-B0A6-0A7006B85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053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407EAD-C0AF-443F-9C40-1B51176DD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A1944-DC1F-42A8-8870-BC05844C7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8E48E4-676F-4C6E-A668-76E75D449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348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34731-069B-4D2E-86CC-46B8E10C0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078011-6F15-4BB0-99B4-36A961F829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57CFDD-3557-463B-AE3A-68A6542E14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EFCF9-7292-4495-AE08-A5F84AD80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84E212-1471-4C9C-B78F-257F4A121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2AD34B-3B8F-4CA5-B058-C7D875C91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5561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F5421-AAF6-4511-89AA-AF56E048C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449EC6-CAB9-46B1-8514-279AF34392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D9AF68-D133-4858-92A0-B3C21AEA7D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DB42E0-B539-4883-B1F6-A86D098BB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5CE6C-FD47-46B9-B836-B9053250B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D5E92-3B49-451D-AEDC-969ACFCEA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19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DE1530-657E-468C-9F24-26688CACC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71D5CA-15B3-4FFA-8FBD-EF47D77CF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41923-F34C-4B6A-9155-4715D266BA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3BE874-CF1B-4AEF-91FA-65608E143E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9D1A2-7E4E-4178-A720-CE963EA688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427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21F483-1254-4497-A2AE-DD9D65EA8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CB1193-95B1-4422-AA91-D776F58B6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5CB6A-D727-4D63-A7E8-220E344123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933E5-4CC0-41F1-B0D1-A9A2EBE7D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AEE3A-31CE-4B95-AC24-963217E53B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572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9B8FD-400E-4DFD-8145-03EA3B5C21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3999" y="1122363"/>
            <a:ext cx="9738049" cy="2387600"/>
          </a:xfrm>
        </p:spPr>
        <p:txBody>
          <a:bodyPr>
            <a:normAutofit/>
          </a:bodyPr>
          <a:lstStyle/>
          <a:p>
            <a:r>
              <a:rPr lang="en-GB" dirty="0"/>
              <a:t>Supplementary Figures 4</a:t>
            </a:r>
            <a:br>
              <a:rPr lang="en-GB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86FBB7-219B-4ABD-9D79-46E73A98296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lnSpcReduction="10000"/>
          </a:bodyPr>
          <a:lstStyle/>
          <a:p>
            <a:r>
              <a:rPr lang="en-GB" dirty="0"/>
              <a:t>Manuscript: Early Access Provision: Awareness, Educational Needs and Opportunities to Improve Oncology Patients’ Access to </a:t>
            </a:r>
            <a:r>
              <a:rPr lang="en-GB"/>
              <a:t>Care </a:t>
            </a:r>
          </a:p>
          <a:p>
            <a:endParaRPr lang="en-GB" dirty="0"/>
          </a:p>
          <a:p>
            <a:r>
              <a:rPr lang="en-GB" dirty="0" err="1"/>
              <a:t>A.Krendyukov</a:t>
            </a:r>
            <a:r>
              <a:rPr lang="en-GB" dirty="0"/>
              <a:t>, </a:t>
            </a:r>
            <a:r>
              <a:rPr lang="en-GB" dirty="0" err="1"/>
              <a:t>S.Singhvi</a:t>
            </a:r>
            <a:r>
              <a:rPr lang="en-GB" dirty="0"/>
              <a:t>, </a:t>
            </a:r>
            <a:r>
              <a:rPr lang="en-US" dirty="0" err="1"/>
              <a:t>Y.Green</a:t>
            </a:r>
            <a:r>
              <a:rPr lang="en-US" dirty="0"/>
              <a:t>-Morrison, </a:t>
            </a:r>
            <a:r>
              <a:rPr lang="en-US" dirty="0" err="1"/>
              <a:t>M.Zabransky</a:t>
            </a:r>
            <a:r>
              <a:rPr lang="en-US" b="1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1788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B3FF9A3-7688-40CE-8C0E-897B1B62D5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2271600"/>
              </p:ext>
            </p:extLst>
          </p:nvPr>
        </p:nvGraphicFramePr>
        <p:xfrm>
          <a:off x="424800" y="1904400"/>
          <a:ext cx="11343600" cy="43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D4A41B86-5910-4F38-8F09-D62C97BC774B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T</a:t>
            </a:r>
            <a:r>
              <a:rPr lang="en-US" sz="3200" i="0" u="none" strike="noStrike" baseline="0" dirty="0">
                <a:effectLst/>
              </a:rPr>
              <a:t>ypical and common challenges faced by practicing physician when dealing with early access provision in daily</a:t>
            </a:r>
            <a:r>
              <a:rPr lang="en-US" sz="3200" i="0" u="none" strike="noStrike" dirty="0">
                <a:effectLst/>
              </a:rPr>
              <a:t> activities </a:t>
            </a:r>
            <a:r>
              <a:rPr lang="en-US" sz="2900" dirty="0">
                <a:effectLst/>
              </a:rPr>
              <a:t>–North America vs Europe</a:t>
            </a:r>
            <a:endParaRPr lang="en-GB" sz="2900" dirty="0"/>
          </a:p>
        </p:txBody>
      </p:sp>
    </p:spTree>
    <p:extLst>
      <p:ext uri="{BB962C8B-B14F-4D97-AF65-F5344CB8AC3E}">
        <p14:creationId xmlns:p14="http://schemas.microsoft.com/office/powerpoint/2010/main" val="1801086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Custom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0FF81"/>
      </a:accent1>
      <a:accent2>
        <a:srgbClr val="08CFEE"/>
      </a:accent2>
      <a:accent3>
        <a:srgbClr val="FFEC00"/>
      </a:accent3>
      <a:accent4>
        <a:srgbClr val="FB90FF"/>
      </a:accent4>
      <a:accent5>
        <a:srgbClr val="FF8300"/>
      </a:accent5>
      <a:accent6>
        <a:srgbClr val="73FBFF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61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1_Office Theme</vt:lpstr>
      <vt:lpstr>Supplementary Figures 4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a Bakowska</dc:creator>
  <cp:lastModifiedBy>Andriy Andriy</cp:lastModifiedBy>
  <cp:revision>4</cp:revision>
  <dcterms:created xsi:type="dcterms:W3CDTF">2022-08-26T10:24:25Z</dcterms:created>
  <dcterms:modified xsi:type="dcterms:W3CDTF">2022-10-21T08:39:52Z</dcterms:modified>
</cp:coreProperties>
</file>